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1E250-3755-42D5-BD99-C78D89EE25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FA1B7B-434F-407D-94AE-9A45394A28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F8D2B-5FAC-4736-ABC5-5EDAAC11E6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03F19-D324-4836-BD7E-9164918709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367BB-2F80-471B-AE5F-D9BAAAD78D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01A441-D455-4E5C-BCBB-48677D11DE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0CA71-2033-4F64-A062-A5673980D3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A574C-CCFF-45DB-A9ED-C44F1B530A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40AAB-0197-4EE4-9316-D60114C6BC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ABE9C-95DD-4EE2-BE46-CCCC329F12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90686-7C38-483C-9B28-C1EEA3D41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F1A74-1D38-44CA-A0A0-6E485832C0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2C3140-3A9C-477C-B24A-6077C8B27BF1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0880" y="1143000"/>
          <a:ext cx="8534520" cy="4232160"/>
        </p:xfrm>
        <a:graphic>
          <a:graphicData uri="http://schemas.openxmlformats.org/drawingml/2006/table">
            <a:tbl>
              <a:tblPr/>
              <a:tblGrid>
                <a:gridCol w="2710080"/>
                <a:gridCol w="5824440"/>
              </a:tblGrid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DN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audin 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NT3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ingless-type MMTV integration site family, member 3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W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W domain containing oxidoreduct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C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yndecan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1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CBLD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scoidin, CUB and LCCL domain containing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uppression of tumorigenicity 14 (colon carcinom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DN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audin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NS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nsin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STR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itric oxide synthase traffick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rforin 1 (pore forming protei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NK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nkyrin 3, node of Ranvier (ankyrin G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RT8P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eratin 8 pseudogene 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J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ight junction protein 2 (zona occludens 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YTL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yltransferase like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RT8P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eratin 8 pseudogene 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H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dherin 3, type 1, P-cadherin (placental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NFSF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umor necrosis factor (ligand) superfamily, member 4 (tax-transcriptionally activated glycoprotein 1, 34kD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C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yndecan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MP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one morphogenetic protein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N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phrin-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JU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junction plakoglob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P1M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aptor-related protein complex 1, mu 2 subuni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NNBI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enin, beta interacting protei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B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B25, member RAS oncogene famil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E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mphiregulin (schwannoma-derived growth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JA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jagged 1 (Alagille syndrom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PPK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piplaki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GF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broblast growth factor 9 (glia-activating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MARCE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WI/SNF related, matrix associated, actin dependent regulator of chromatin, subfamily e, member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itle 1"/>
          <p:cNvSpPr/>
          <p:nvPr/>
        </p:nvSpPr>
        <p:spPr>
          <a:xfrm>
            <a:off x="0" y="-36360"/>
            <a:ext cx="2830680" cy="68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1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8:27Z</dcterms:modified>
  <cp:revision>256</cp:revision>
  <dc:subject/>
  <dc:title>Diapositiva 1</dc:title>
</cp:coreProperties>
</file>